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3" r:id="rId2"/>
    <p:sldId id="264" r:id="rId3"/>
    <p:sldId id="265" r:id="rId4"/>
    <p:sldId id="26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108" y="6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8854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15027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46824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4161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2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877272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oughton and Hovorka (2021) Diabetologia DOI 10.1007/s00125-021-05391-w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chematic of the configuration of closed-loop insulin delivery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212D6F5-7B86-493D-90E7-0802FEA6F57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5820" y="1540269"/>
            <a:ext cx="7812360" cy="35449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1384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Key developmental milestones towards a truly artificial pancrea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79A1314-1577-4BA0-9056-8CC17D06B9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5497" y="816058"/>
            <a:ext cx="7309030" cy="470324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43C5C6B-1B96-401C-90DB-BB85679550D4}"/>
              </a:ext>
            </a:extLst>
          </p:cNvPr>
          <p:cNvSpPr txBox="1"/>
          <p:nvPr/>
        </p:nvSpPr>
        <p:spPr>
          <a:xfrm>
            <a:off x="251520" y="5877272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oughton and Hovorka (2021) Diabetologia DOI 10.1007/s00125-021-05391-w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9851379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877272"/>
            <a:ext cx="799288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oughton and Hovorka (2021) Diabetologia DOI 10.1007/s00125-021-05391-w </a:t>
            </a:r>
          </a:p>
          <a:p>
            <a:r>
              <a:rPr lang="en-GB" sz="1200" dirty="0"/>
              <a:t>Image credit: </a:t>
            </a:r>
            <a:r>
              <a:rPr lang="en-GB" sz="1200" dirty="0" err="1"/>
              <a:t>Glooko</a:t>
            </a:r>
            <a:r>
              <a:rPr lang="en-GB" sz="1200" dirty="0"/>
              <a:t> Inc. All rights reserved. 202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Hybrid closed-loop glucose control:(a) 24 h of sensor glucose data. </a:t>
            </a:r>
          </a:p>
          <a:p>
            <a:r>
              <a:rPr lang="en-GB" sz="2000" b="1" dirty="0"/>
              <a:t>(b) Algorithm-driven insulin delivery and manual insulin boluses. </a:t>
            </a:r>
          </a:p>
          <a:p>
            <a:r>
              <a:rPr lang="en-GB" sz="2000" b="1" dirty="0"/>
              <a:t>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138E1CC-CC30-4FA2-87F6-EB7346C502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03648" y="1151342"/>
            <a:ext cx="5948997" cy="45819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53623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877272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oughton and Hovorka (2021) Diabetologia DOI 10.1007/s00125-021-05391-w </a:t>
            </a:r>
          </a:p>
          <a:p>
            <a:r>
              <a:rPr lang="en-GB" sz="1200" dirty="0"/>
              <a:t>©2019 Massachusetts Medical Society. Adapted from Brown et al, reprinted with permission from </a:t>
            </a:r>
          </a:p>
          <a:p>
            <a:r>
              <a:rPr lang="en-GB" sz="1200" dirty="0"/>
              <a:t>Massachusetts Medical Society.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Median percentage time with sensor glucose in target range during closed-loop insulin delivery and sensor-augmented pump therapy (control) in adults and adolescents ≥14 years of age, using the Tandem Control-IQ closed-loop system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C436300-29CB-41A8-942C-1797A5453A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8123" y="2000440"/>
            <a:ext cx="6207754" cy="3006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5846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</TotalTime>
  <Words>215</Words>
  <Application>Microsoft Office PowerPoint</Application>
  <PresentationFormat>On-screen Show (4:3)</PresentationFormat>
  <Paragraphs>19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40</cp:revision>
  <dcterms:created xsi:type="dcterms:W3CDTF">2016-06-15T12:53:43Z</dcterms:created>
  <dcterms:modified xsi:type="dcterms:W3CDTF">2021-02-02T16:01:25Z</dcterms:modified>
</cp:coreProperties>
</file>